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 snapToObjects="1">
      <p:cViewPr varScale="1">
        <p:scale>
          <a:sx n="86" d="100"/>
          <a:sy n="86" d="100"/>
        </p:scale>
        <p:origin x="345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5C8F54-2FB0-3D49-ACC2-0E30AF4C22E2}" type="datetimeFigureOut">
              <a:rPr lang="en-GB" smtClean="0"/>
              <a:t>18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CFE7E7-CF2C-7548-88BA-E0F9C79BA2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646715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5C8F54-2FB0-3D49-ACC2-0E30AF4C22E2}" type="datetimeFigureOut">
              <a:rPr lang="en-GB" smtClean="0"/>
              <a:t>18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CFE7E7-CF2C-7548-88BA-E0F9C79BA2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393110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5C8F54-2FB0-3D49-ACC2-0E30AF4C22E2}" type="datetimeFigureOut">
              <a:rPr lang="en-GB" smtClean="0"/>
              <a:t>18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CFE7E7-CF2C-7548-88BA-E0F9C79BA2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506164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5C8F54-2FB0-3D49-ACC2-0E30AF4C22E2}" type="datetimeFigureOut">
              <a:rPr lang="en-GB" smtClean="0"/>
              <a:t>18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CFE7E7-CF2C-7548-88BA-E0F9C79BA2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624072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5C8F54-2FB0-3D49-ACC2-0E30AF4C22E2}" type="datetimeFigureOut">
              <a:rPr lang="en-GB" smtClean="0"/>
              <a:t>18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CFE7E7-CF2C-7548-88BA-E0F9C79BA2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60596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5C8F54-2FB0-3D49-ACC2-0E30AF4C22E2}" type="datetimeFigureOut">
              <a:rPr lang="en-GB" smtClean="0"/>
              <a:t>18/06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CFE7E7-CF2C-7548-88BA-E0F9C79BA2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11172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5C8F54-2FB0-3D49-ACC2-0E30AF4C22E2}" type="datetimeFigureOut">
              <a:rPr lang="en-GB" smtClean="0"/>
              <a:t>18/06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CFE7E7-CF2C-7548-88BA-E0F9C79BA2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89998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5C8F54-2FB0-3D49-ACC2-0E30AF4C22E2}" type="datetimeFigureOut">
              <a:rPr lang="en-GB" smtClean="0"/>
              <a:t>18/06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CFE7E7-CF2C-7548-88BA-E0F9C79BA2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20693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5C8F54-2FB0-3D49-ACC2-0E30AF4C22E2}" type="datetimeFigureOut">
              <a:rPr lang="en-GB" smtClean="0"/>
              <a:t>18/06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CFE7E7-CF2C-7548-88BA-E0F9C79BA2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13433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5C8F54-2FB0-3D49-ACC2-0E30AF4C22E2}" type="datetimeFigureOut">
              <a:rPr lang="en-GB" smtClean="0"/>
              <a:t>18/06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CFE7E7-CF2C-7548-88BA-E0F9C79BA2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3969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5C8F54-2FB0-3D49-ACC2-0E30AF4C22E2}" type="datetimeFigureOut">
              <a:rPr lang="en-GB" smtClean="0"/>
              <a:t>18/06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CFE7E7-CF2C-7548-88BA-E0F9C79BA2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96017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5C8F54-2FB0-3D49-ACC2-0E30AF4C22E2}" type="datetimeFigureOut">
              <a:rPr lang="en-GB" smtClean="0"/>
              <a:t>18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CFE7E7-CF2C-7548-88BA-E0F9C79BA2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63077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E8E62347-5AB8-B44E-AB8F-57E2A6CEEA8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427" t="51960" r="19165" b="16452"/>
          <a:stretch/>
        </p:blipFill>
        <p:spPr>
          <a:xfrm>
            <a:off x="388183" y="446173"/>
            <a:ext cx="3111102" cy="1761003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0AEDB10C-ADBF-144C-8D17-364A357822B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2598" t="38273" r="14840" b="7817"/>
          <a:stretch/>
        </p:blipFill>
        <p:spPr>
          <a:xfrm>
            <a:off x="3828068" y="369259"/>
            <a:ext cx="2876411" cy="2849405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47622D18-7F8F-F843-930F-2215F971ED1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5515" t="9123" r="14985" b="12901"/>
          <a:stretch/>
        </p:blipFill>
        <p:spPr>
          <a:xfrm>
            <a:off x="494563" y="2512679"/>
            <a:ext cx="2764992" cy="4136304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D798411E-A023-D54C-8894-F86F5903A9B3}"/>
              </a:ext>
            </a:extLst>
          </p:cNvPr>
          <p:cNvSpPr txBox="1"/>
          <p:nvPr/>
        </p:nvSpPr>
        <p:spPr>
          <a:xfrm>
            <a:off x="254834" y="8124668"/>
            <a:ext cx="6449646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/>
              <a:t>Supplementary Figure 1 A-D. </a:t>
            </a:r>
            <a:r>
              <a:rPr lang="en-GB" sz="1100" dirty="0"/>
              <a:t>Example packaging for several antimicrobials obtained from agrovet shops from Busia County. Of note is the simplistic withdrawal periods marked on the packaging, and in some cases e.g., C), a lack of withdrawal period altogether.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415745DE-4966-5E41-9199-0B4E5559B169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33389" t="17539" r="22523" b="33581"/>
          <a:stretch/>
        </p:blipFill>
        <p:spPr>
          <a:xfrm>
            <a:off x="4008237" y="3346351"/>
            <a:ext cx="2234133" cy="3302632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BB16A4E8-EDEE-7047-B994-BC9D8510CCD4}"/>
              </a:ext>
            </a:extLst>
          </p:cNvPr>
          <p:cNvSpPr txBox="1"/>
          <p:nvPr/>
        </p:nvSpPr>
        <p:spPr>
          <a:xfrm>
            <a:off x="60660" y="141169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A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2C4B967-B701-424D-AD07-FA6F391FE1A2}"/>
              </a:ext>
            </a:extLst>
          </p:cNvPr>
          <p:cNvSpPr txBox="1"/>
          <p:nvPr/>
        </p:nvSpPr>
        <p:spPr>
          <a:xfrm>
            <a:off x="3499285" y="123370"/>
            <a:ext cx="3866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B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FD28CF1-FF2E-E041-A14F-8B86CB2B95E7}"/>
              </a:ext>
            </a:extLst>
          </p:cNvPr>
          <p:cNvSpPr txBox="1"/>
          <p:nvPr/>
        </p:nvSpPr>
        <p:spPr>
          <a:xfrm>
            <a:off x="165780" y="2396847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C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9FF65D5-E845-6F44-9CD7-C50D6BCD3DF8}"/>
              </a:ext>
            </a:extLst>
          </p:cNvPr>
          <p:cNvSpPr txBox="1"/>
          <p:nvPr/>
        </p:nvSpPr>
        <p:spPr>
          <a:xfrm>
            <a:off x="3631211" y="3287146"/>
            <a:ext cx="402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D)</a:t>
            </a:r>
          </a:p>
        </p:txBody>
      </p:sp>
    </p:spTree>
    <p:extLst>
      <p:ext uri="{BB962C8B-B14F-4D97-AF65-F5344CB8AC3E}">
        <p14:creationId xmlns:p14="http://schemas.microsoft.com/office/powerpoint/2010/main" val="6806229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</TotalTime>
  <Words>55</Words>
  <Application>Microsoft Macintosh PowerPoint</Application>
  <PresentationFormat>A4 Paper (210x297 mm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mp, Steven</dc:creator>
  <cp:lastModifiedBy>Kemp, Steven</cp:lastModifiedBy>
  <cp:revision>2</cp:revision>
  <dcterms:created xsi:type="dcterms:W3CDTF">2021-06-17T14:25:49Z</dcterms:created>
  <dcterms:modified xsi:type="dcterms:W3CDTF">2021-06-18T11:36:41Z</dcterms:modified>
</cp:coreProperties>
</file>